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48" d="100"/>
          <a:sy n="48" d="100"/>
        </p:scale>
        <p:origin x="489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77C5BB-3AB2-4CB7-B6F9-D5ABBAE4AB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C95A89A-51AE-4335-9759-C7CFA07E16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D9F985-8DB2-45FA-AB3D-6E0881A70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610CC8-3AD0-457E-A4CA-7149B8B5B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64B2B4-B8D0-4C9E-86FD-0C43FC8B8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4214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50B623-87FF-49DF-84F2-6D14CB0367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E06363-E37C-4688-8DB8-69C45B8316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1BBEC9-6D16-4C62-BB39-C3F3041A3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5BD91A-F616-4FFC-A6B6-E6A4EAF66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B274FB-5DF7-481C-A8DB-C1059D48C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6977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744A600-115C-46ED-8CC5-73A8E827D5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0360451-4B20-40C7-BABC-7DA5E17FDD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7CEE6-D779-4A9A-80F3-A95FC92E2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3BB724F-009C-4222-AABE-C385F10B0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A512BE-793C-4C63-89D8-A14E9706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8702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26747A-DF4E-4D65-9736-0797153486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7F33950-322B-4C34-87EF-98F2B4BF5A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E6365A-9355-4F18-8A73-C01FADDED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CFB4EE-CCE3-4410-8193-C68DBFE57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885750-4D42-4D21-8474-A7B28D5BE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4142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F00E0C-2A96-4044-B8C1-4D874FCED9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2D32AC-67EE-4AB0-A641-EC7185B520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C648B3-15ED-4151-9B7E-8281D4617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3A0388-12C9-45AF-AD63-966486E6C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BB1D41-F3DA-4F60-B246-8BF6ACBFB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50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3A971A-16D3-4863-B7C7-BAFC05404C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ACAAE00-5A04-499F-B464-45110D2AF6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4220C0-305E-4943-9611-43A1BC8C0B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B798227-F48F-4B0D-842A-1B1F36EE2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9E8BF4-A555-4131-8F77-B3DD9D720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DE9B76-2637-4B51-A25F-34BBA3F48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2635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27AA4C-CEA0-4CC9-94B9-3C58E409EF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0E02954-C379-4C5A-A413-CE03A16A07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376A11D-5AA9-4473-A1F2-0CFF413119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C0BFFAB-2086-484F-83AB-0CB16F0275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066947A-8C8B-4E75-9079-8F8655D136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9117C4-BE18-437E-9386-0A2049A22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F09CA56-1156-49C9-A1BD-6CB6C2460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81D87EB-997C-4235-B28C-DAF1C817E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435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EB470B-612B-4978-BDF0-66FD234A9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1E6478F-A91C-4CDA-8626-35FD579C1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B893A54-C1E0-45F4-B7A5-5D226672A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438A1CC-6110-467F-A4E2-FC6E793D2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964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F747136-7969-4E10-8969-F8781413E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3E29DFB-31BA-468E-8D00-E66D36DF4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E1B2B90-A830-4C01-AB81-B1A14FE4B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0745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5CF19F-C42B-4AF8-9AD7-8E7C2A47E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B13ED7-E0F5-4AE3-AB98-09B92D5FFF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4A87F34-F365-4A39-B435-534242C690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770CA9-E700-4E5A-965C-F14EAA162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B511F5-D751-44F0-B5EC-99C630D95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4B9156-9F7C-4FA1-B704-16F3A6BBB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5050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717C41-DB03-4766-AE47-6BD9E5EEE9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7F64774-4AE8-40A8-B5CB-6AC6579CC9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2C756A3-F9C4-4F6A-915D-DE008EB677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0C6353-015D-402B-A277-1A9C82F0D2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5A28059-E866-409B-A36B-C802DEF3E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9ED8D48-B570-4D86-8D4B-8A1566E15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982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1B0C4AD-2340-4C85-AE06-D44A622A6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E87117-B674-4CD0-9A75-24FF92F3DE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3789C9-63F0-40E5-9E37-F9E02D7EFC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3A5E2-98A3-4F73-B30A-F2882CBC021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D37E40-26AE-4306-8715-4CD50BB85E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CDD5AB-2CAD-4504-82C8-369556631A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09DFA8-B297-4B36-B723-1158998AD8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7753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85E503A-FAAC-40F3-B2F2-07AAFFA78F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6492" y="1921764"/>
            <a:ext cx="4319016" cy="301447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DAC0C8F-C11F-4897-91D5-646EB3DCA380}"/>
              </a:ext>
            </a:extLst>
          </p:cNvPr>
          <p:cNvSpPr txBox="1"/>
          <p:nvPr/>
        </p:nvSpPr>
        <p:spPr>
          <a:xfrm>
            <a:off x="1355904" y="5284496"/>
            <a:ext cx="93705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</a:t>
            </a:r>
            <a:r>
              <a:rPr lang="en-US" altLang="zh-CN" b="1" kern="10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800" b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g. 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ierarchical clustering showed the different metabolites in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ESI+ and ESI- 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86567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欢</dc:creator>
  <cp:lastModifiedBy>李 欢</cp:lastModifiedBy>
  <cp:revision>3</cp:revision>
  <dcterms:created xsi:type="dcterms:W3CDTF">2022-04-29T06:43:39Z</dcterms:created>
  <dcterms:modified xsi:type="dcterms:W3CDTF">2023-03-23T09:20:43Z</dcterms:modified>
</cp:coreProperties>
</file>